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9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02" autoAdjust="0"/>
    <p:restoredTop sz="63760" autoAdjust="0"/>
  </p:normalViewPr>
  <p:slideViewPr>
    <p:cSldViewPr>
      <p:cViewPr>
        <p:scale>
          <a:sx n="100" d="100"/>
          <a:sy n="100" d="100"/>
        </p:scale>
        <p:origin x="-2064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7257D7-D7BE-4475-912D-A861A539B70E}" type="datetimeFigureOut">
              <a:rPr lang="it-IT" smtClean="0"/>
              <a:t>14/12/201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067331-E300-493D-B25C-E95C2384BC2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19488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6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4DDC09-3A55-4B16-AD34-7AD3F499AB41}" type="datetimeFigureOut">
              <a:rPr lang="it-IT" smtClean="0"/>
              <a:t>14/12/2015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5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6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1D5D10-F67F-430D-926A-A83F6D16763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08719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09788" y="744538"/>
            <a:ext cx="2578100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1D5D10-F67F-430D-926A-A83F6D16763D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572091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9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7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7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92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13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402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Box 26"/>
          <p:cNvSpPr txBox="1">
            <a:spLocks noChangeArrowheads="1"/>
          </p:cNvSpPr>
          <p:nvPr/>
        </p:nvSpPr>
        <p:spPr bwMode="auto">
          <a:xfrm rot="16200000">
            <a:off x="232804" y="1512555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 Box 26"/>
          <p:cNvSpPr txBox="1">
            <a:spLocks noChangeArrowheads="1"/>
          </p:cNvSpPr>
          <p:nvPr/>
        </p:nvSpPr>
        <p:spPr bwMode="auto">
          <a:xfrm rot="16200000">
            <a:off x="242328" y="3320898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XAV939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 Box 26"/>
          <p:cNvSpPr txBox="1">
            <a:spLocks noChangeArrowheads="1"/>
          </p:cNvSpPr>
          <p:nvPr/>
        </p:nvSpPr>
        <p:spPr bwMode="auto">
          <a:xfrm rot="16200000">
            <a:off x="239161" y="5148111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JNJ-BJ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4374105" y="9588515"/>
            <a:ext cx="24497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upo et al.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dditional File 12: Figure S4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Connettore 1 55"/>
          <p:cNvCxnSpPr/>
          <p:nvPr/>
        </p:nvCxnSpPr>
        <p:spPr>
          <a:xfrm>
            <a:off x="528748" y="1831361"/>
            <a:ext cx="324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6" name="Picture 2" descr="K:\## Molecular Oncology\Livio Trusolino\Confocal\Group\IF Barbara\Microtubule stability\2-MT stability 1st exp- fluo_VENUTO BENE\foto per paper\1-DMSO_NT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6033" y="717940"/>
            <a:ext cx="2408237" cy="18018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K:\## Molecular Oncology\Livio Trusolino\Confocal\Group\IF Barbara\Microtubule stability\2-MT stability 1st exp- fluo_VENUTO BENE\foto per paper\2-JNJ272_NT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8834" y="2535408"/>
            <a:ext cx="2411413" cy="18018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K:\## Molecular Oncology\Livio Trusolino\Confocal\Group\IF Barbara\Microtubule stability\2-MT stability 1st exp- fluo_VENUTO BENE\foto per paper\3-JNJ928_NT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8834" y="4362621"/>
            <a:ext cx="2408237" cy="18018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K:\## Molecular Oncology\Livio Trusolino\Confocal\Group\IF Barbara\Microtubule stability\2-MT stability 1st exp- fluo_VENUTO BENE\foto per paper\4-DMSO_noco1uM5min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3086" y="727065"/>
            <a:ext cx="2408237" cy="18018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K:\## Molecular Oncology\Livio Trusolino\Confocal\Group\IF Barbara\Microtubule stability\2-MT stability 1st exp- fluo_VENUTO BENE\foto per paper\5-JNJ272_noco1uM5min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9910" y="2535408"/>
            <a:ext cx="2411413" cy="18018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K:\## Molecular Oncology\Livio Trusolino\Confocal\Group\IF Barbara\Microtubule stability\2-MT stability 1st exp- fluo_VENUTO BENE\foto per paper\6-JNJ928_noco1uM5min.ti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9535" y="4374840"/>
            <a:ext cx="2411413" cy="18018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 Box 26"/>
          <p:cNvSpPr txBox="1">
            <a:spLocks noChangeArrowheads="1"/>
          </p:cNvSpPr>
          <p:nvPr/>
        </p:nvSpPr>
        <p:spPr bwMode="auto">
          <a:xfrm>
            <a:off x="1575921" y="426148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 Box 26"/>
          <p:cNvSpPr txBox="1">
            <a:spLocks noChangeArrowheads="1"/>
          </p:cNvSpPr>
          <p:nvPr/>
        </p:nvSpPr>
        <p:spPr bwMode="auto">
          <a:xfrm>
            <a:off x="4043962" y="407495"/>
            <a:ext cx="92255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codazole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Picture 12" descr="K:\## Molecular Oncology\Livio Trusolino\Confocal\Group\IF Barbara\Microtubule stability\2-MT stability 1st exp- fluo_VENUTO BENE\foto per paper\crop\height 5\1-DMSO_NT.tif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60160" y="1713813"/>
            <a:ext cx="994110" cy="80594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5" descr="K:\## Molecular Oncology\Livio Trusolino\Confocal\Group\IF Barbara\Microtubule stability\2-MT stability 1st exp- fluo_VENUTO BENE\foto per paper\crop\height 5\4-DMSO_noco1uM5min.ti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2552" y="1722633"/>
            <a:ext cx="995531" cy="80594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13" descr="K:\## Molecular Oncology\Livio Trusolino\Confocal\Group\IF Barbara\Microtubule stability\2-MT stability 1st exp- fluo_VENUTO BENE\foto per paper\crop\height 5\2-JNJ272_NT.tif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5254" y="3526531"/>
            <a:ext cx="995531" cy="80594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16" descr="K:\## Molecular Oncology\Livio Trusolino\Confocal\Group\IF Barbara\Microtubule stability\2-MT stability 1st exp- fluo_VENUTO BENE\foto per paper\crop\height 5\5-JNJ272_noco1uM5min.tif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5792" y="3526531"/>
            <a:ext cx="995531" cy="80594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14" descr="K:\## Molecular Oncology\Livio Trusolino\Confocal\Group\IF Barbara\Microtubule stability\2-MT stability 1st exp- fluo_VENUTO BENE\foto per paper\crop\height 5\3-JNJ928_NT.tif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5356" y="5358004"/>
            <a:ext cx="995531" cy="80594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17" descr="K:\## Molecular Oncology\Livio Trusolino\Confocal\Group\IF Barbara\Microtubule stability\2-MT stability 1st exp- fluo_VENUTO BENE\foto per paper\crop\height 5\6-JNJ928_noco1uM5min.tif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2552" y="5367529"/>
            <a:ext cx="994110" cy="80594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1" name="Connettore 1 55"/>
          <p:cNvCxnSpPr/>
          <p:nvPr/>
        </p:nvCxnSpPr>
        <p:spPr>
          <a:xfrm>
            <a:off x="818710" y="2432720"/>
            <a:ext cx="324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ttore 1 55"/>
          <p:cNvCxnSpPr/>
          <p:nvPr/>
        </p:nvCxnSpPr>
        <p:spPr>
          <a:xfrm>
            <a:off x="2333215" y="2446090"/>
            <a:ext cx="648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490312" y="6536012"/>
            <a:ext cx="6089038" cy="1708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2: Figure S4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he microtubule network is stabilized by TNKS pharmacologic neutralization</a:t>
            </a:r>
            <a:endParaRPr lang="it-IT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pifluorescence images of the microtubule network in the presence or absence of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codazole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tarved A549 cells were pre-incubated for 24 h with or without TNKS inhibitors (10 </a:t>
            </a:r>
            <a:r>
              <a:rPr lang="en-US" sz="1000" dirty="0">
                <a:latin typeface="Symbol" panose="05050102010706020507" pitchFamily="18" charset="2"/>
                <a:cs typeface="Arial" panose="020B0604020202020204" pitchFamily="34" charset="0"/>
              </a:rPr>
              <a:t>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) and the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reated with DMSO (control) or 1 </a:t>
            </a:r>
            <a:r>
              <a:rPr lang="en-US" sz="10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codazole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for 5 min before fixation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nd staining with anti-</a:t>
            </a:r>
            <a:r>
              <a:rPr lang="en-US" sz="1000" dirty="0">
                <a:latin typeface="Symbol" panose="05050102010706020507" pitchFamily="18" charset="2"/>
                <a:cs typeface="Arial" panose="020B0604020202020204" pitchFamily="34" charset="0"/>
              </a:rPr>
              <a:t>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tubulin antibody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sets show higher magnification fields. Scal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ar, 7 </a:t>
            </a:r>
            <a:r>
              <a:rPr lang="en-US" sz="1000" dirty="0">
                <a:latin typeface="Symbol" panose="05050102010706020507" pitchFamily="18" charset="2"/>
                <a:cs typeface="Arial" panose="020B0604020202020204" pitchFamily="34" charset="0"/>
              </a:rPr>
              <a:t>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. Images are representative of one experiment out of two performed. 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09253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027</TotalTime>
  <Words>114</Words>
  <Application>Microsoft Office PowerPoint</Application>
  <PresentationFormat>A4 Paper (210x297 mm)</PresentationFormat>
  <Paragraphs>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ara Lupo</dc:creator>
  <cp:lastModifiedBy>ltrusolino</cp:lastModifiedBy>
  <cp:revision>527</cp:revision>
  <cp:lastPrinted>2015-11-17T17:24:08Z</cp:lastPrinted>
  <dcterms:created xsi:type="dcterms:W3CDTF">2006-08-16T00:00:00Z</dcterms:created>
  <dcterms:modified xsi:type="dcterms:W3CDTF">2015-12-14T09:56:23Z</dcterms:modified>
</cp:coreProperties>
</file>